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348" r:id="rId4"/>
    <p:sldId id="345" r:id="rId5"/>
    <p:sldId id="346" r:id="rId6"/>
    <p:sldId id="350" r:id="rId7"/>
    <p:sldId id="347" r:id="rId8"/>
    <p:sldId id="349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9" autoAdjust="0"/>
    <p:restoredTop sz="94660"/>
  </p:normalViewPr>
  <p:slideViewPr>
    <p:cSldViewPr snapToGrid="0" showGuides="1">
      <p:cViewPr varScale="1">
        <p:scale>
          <a:sx n="160" d="100"/>
          <a:sy n="160" d="100"/>
        </p:scale>
        <p:origin x="258" y="13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Wilson, Iain (A&amp;F, Black Mountain)" userId="38bfd345-1638-4364-807f-ad09d9a3cd4c" providerId="ADAL" clId="{C75939C2-CE78-4B04-B436-754E9745B2B3}"/>
    <pc:docChg chg="custSel addSld delSld modSld">
      <pc:chgData name="Wilson, Iain (A&amp;F, Black Mountain)" userId="38bfd345-1638-4364-807f-ad09d9a3cd4c" providerId="ADAL" clId="{C75939C2-CE78-4B04-B436-754E9745B2B3}" dt="2023-11-29T02:40:48.827" v="14" actId="20577"/>
      <pc:docMkLst>
        <pc:docMk/>
      </pc:docMkLst>
      <pc:sldChg chg="delSp del mod">
        <pc:chgData name="Wilson, Iain (A&amp;F, Black Mountain)" userId="38bfd345-1638-4364-807f-ad09d9a3cd4c" providerId="ADAL" clId="{C75939C2-CE78-4B04-B436-754E9745B2B3}" dt="2023-11-24T02:30:04.942" v="3" actId="47"/>
        <pc:sldMkLst>
          <pc:docMk/>
          <pc:sldMk cId="2478636310" sldId="256"/>
        </pc:sldMkLst>
        <pc:spChg chg="del">
          <ac:chgData name="Wilson, Iain (A&amp;F, Black Mountain)" userId="38bfd345-1638-4364-807f-ad09d9a3cd4c" providerId="ADAL" clId="{C75939C2-CE78-4B04-B436-754E9745B2B3}" dt="2023-11-24T02:29:09.857" v="0" actId="478"/>
          <ac:spMkLst>
            <pc:docMk/>
            <pc:sldMk cId="2478636310" sldId="256"/>
            <ac:spMk id="2" creationId="{37076493-08F3-E51C-24C0-0E1D96AD0A25}"/>
          </ac:spMkLst>
        </pc:spChg>
        <pc:spChg chg="del">
          <ac:chgData name="Wilson, Iain (A&amp;F, Black Mountain)" userId="38bfd345-1638-4364-807f-ad09d9a3cd4c" providerId="ADAL" clId="{C75939C2-CE78-4B04-B436-754E9745B2B3}" dt="2023-11-24T02:29:11.014" v="1" actId="478"/>
          <ac:spMkLst>
            <pc:docMk/>
            <pc:sldMk cId="2478636310" sldId="256"/>
            <ac:spMk id="3" creationId="{88FF2CB2-723A-FF80-9F41-68647DF5815C}"/>
          </ac:spMkLst>
        </pc:spChg>
      </pc:sldChg>
      <pc:sldChg chg="add">
        <pc:chgData name="Wilson, Iain (A&amp;F, Black Mountain)" userId="38bfd345-1638-4364-807f-ad09d9a3cd4c" providerId="ADAL" clId="{C75939C2-CE78-4B04-B436-754E9745B2B3}" dt="2023-11-24T02:30:01.198" v="2"/>
        <pc:sldMkLst>
          <pc:docMk/>
          <pc:sldMk cId="4191520162" sldId="257"/>
        </pc:sldMkLst>
      </pc:sldChg>
      <pc:sldChg chg="add">
        <pc:chgData name="Wilson, Iain (A&amp;F, Black Mountain)" userId="38bfd345-1638-4364-807f-ad09d9a3cd4c" providerId="ADAL" clId="{C75939C2-CE78-4B04-B436-754E9745B2B3}" dt="2023-11-24T02:30:01.198" v="2"/>
        <pc:sldMkLst>
          <pc:docMk/>
          <pc:sldMk cId="998421246" sldId="258"/>
        </pc:sldMkLst>
      </pc:sldChg>
      <pc:sldChg chg="delSp new del mod">
        <pc:chgData name="Wilson, Iain (A&amp;F, Black Mountain)" userId="38bfd345-1638-4364-807f-ad09d9a3cd4c" providerId="ADAL" clId="{C75939C2-CE78-4B04-B436-754E9745B2B3}" dt="2023-11-29T02:40:22.115" v="8" actId="47"/>
        <pc:sldMkLst>
          <pc:docMk/>
          <pc:sldMk cId="918270148" sldId="259"/>
        </pc:sldMkLst>
        <pc:spChg chg="del">
          <ac:chgData name="Wilson, Iain (A&amp;F, Black Mountain)" userId="38bfd345-1638-4364-807f-ad09d9a3cd4c" providerId="ADAL" clId="{C75939C2-CE78-4B04-B436-754E9745B2B3}" dt="2023-11-24T03:41:01.160" v="5" actId="478"/>
          <ac:spMkLst>
            <pc:docMk/>
            <pc:sldMk cId="918270148" sldId="259"/>
            <ac:spMk id="2" creationId="{CD89A0A0-A8DA-1BE0-85E0-2740DE18CC03}"/>
          </ac:spMkLst>
        </pc:spChg>
        <pc:spChg chg="del">
          <ac:chgData name="Wilson, Iain (A&amp;F, Black Mountain)" userId="38bfd345-1638-4364-807f-ad09d9a3cd4c" providerId="ADAL" clId="{C75939C2-CE78-4B04-B436-754E9745B2B3}" dt="2023-11-24T03:41:03.383" v="6" actId="478"/>
          <ac:spMkLst>
            <pc:docMk/>
            <pc:sldMk cId="918270148" sldId="259"/>
            <ac:spMk id="3" creationId="{67E473BE-F02A-22EF-98AF-E7F03AB0181E}"/>
          </ac:spMkLst>
        </pc:spChg>
      </pc:sldChg>
      <pc:sldChg chg="modSp add mod">
        <pc:chgData name="Wilson, Iain (A&amp;F, Black Mountain)" userId="38bfd345-1638-4364-807f-ad09d9a3cd4c" providerId="ADAL" clId="{C75939C2-CE78-4B04-B436-754E9745B2B3}" dt="2023-11-29T02:40:32.692" v="10" actId="20577"/>
        <pc:sldMkLst>
          <pc:docMk/>
          <pc:sldMk cId="2104518859" sldId="345"/>
        </pc:sldMkLst>
        <pc:spChg chg="mod">
          <ac:chgData name="Wilson, Iain (A&amp;F, Black Mountain)" userId="38bfd345-1638-4364-807f-ad09d9a3cd4c" providerId="ADAL" clId="{C75939C2-CE78-4B04-B436-754E9745B2B3}" dt="2023-11-29T02:40:32.692" v="10" actId="20577"/>
          <ac:spMkLst>
            <pc:docMk/>
            <pc:sldMk cId="2104518859" sldId="345"/>
            <ac:spMk id="5" creationId="{CD042B15-0ECF-F82D-6E72-D95EA4968056}"/>
          </ac:spMkLst>
        </pc:spChg>
      </pc:sldChg>
      <pc:sldChg chg="modSp add mod">
        <pc:chgData name="Wilson, Iain (A&amp;F, Black Mountain)" userId="38bfd345-1638-4364-807f-ad09d9a3cd4c" providerId="ADAL" clId="{C75939C2-CE78-4B04-B436-754E9745B2B3}" dt="2023-11-29T02:40:36.052" v="11" actId="20577"/>
        <pc:sldMkLst>
          <pc:docMk/>
          <pc:sldMk cId="2093314721" sldId="346"/>
        </pc:sldMkLst>
        <pc:spChg chg="mod">
          <ac:chgData name="Wilson, Iain (A&amp;F, Black Mountain)" userId="38bfd345-1638-4364-807f-ad09d9a3cd4c" providerId="ADAL" clId="{C75939C2-CE78-4B04-B436-754E9745B2B3}" dt="2023-11-29T02:40:36.052" v="11" actId="20577"/>
          <ac:spMkLst>
            <pc:docMk/>
            <pc:sldMk cId="2093314721" sldId="346"/>
            <ac:spMk id="5" creationId="{C78A81F4-1564-1DFC-8B11-6AFAF2F29106}"/>
          </ac:spMkLst>
        </pc:spChg>
      </pc:sldChg>
      <pc:sldChg chg="modSp add mod">
        <pc:chgData name="Wilson, Iain (A&amp;F, Black Mountain)" userId="38bfd345-1638-4364-807f-ad09d9a3cd4c" providerId="ADAL" clId="{C75939C2-CE78-4B04-B436-754E9745B2B3}" dt="2023-11-29T02:40:44.349" v="13" actId="20577"/>
        <pc:sldMkLst>
          <pc:docMk/>
          <pc:sldMk cId="1119347305" sldId="347"/>
        </pc:sldMkLst>
        <pc:spChg chg="mod">
          <ac:chgData name="Wilson, Iain (A&amp;F, Black Mountain)" userId="38bfd345-1638-4364-807f-ad09d9a3cd4c" providerId="ADAL" clId="{C75939C2-CE78-4B04-B436-754E9745B2B3}" dt="2023-11-29T02:40:44.349" v="13" actId="20577"/>
          <ac:spMkLst>
            <pc:docMk/>
            <pc:sldMk cId="1119347305" sldId="347"/>
            <ac:spMk id="5" creationId="{BBEAF3A4-BB60-0CD3-5F77-FACFB1A297D4}"/>
          </ac:spMkLst>
        </pc:spChg>
      </pc:sldChg>
      <pc:sldChg chg="modSp add mod">
        <pc:chgData name="Wilson, Iain (A&amp;F, Black Mountain)" userId="38bfd345-1638-4364-807f-ad09d9a3cd4c" providerId="ADAL" clId="{C75939C2-CE78-4B04-B436-754E9745B2B3}" dt="2023-11-29T02:40:28.306" v="9" actId="20577"/>
        <pc:sldMkLst>
          <pc:docMk/>
          <pc:sldMk cId="3939613883" sldId="348"/>
        </pc:sldMkLst>
        <pc:spChg chg="mod">
          <ac:chgData name="Wilson, Iain (A&amp;F, Black Mountain)" userId="38bfd345-1638-4364-807f-ad09d9a3cd4c" providerId="ADAL" clId="{C75939C2-CE78-4B04-B436-754E9745B2B3}" dt="2023-11-29T02:40:28.306" v="9" actId="20577"/>
          <ac:spMkLst>
            <pc:docMk/>
            <pc:sldMk cId="3939613883" sldId="348"/>
            <ac:spMk id="5" creationId="{6C73BFD1-B14F-5826-EA39-D18B75FA1528}"/>
          </ac:spMkLst>
        </pc:spChg>
      </pc:sldChg>
      <pc:sldChg chg="modSp add mod">
        <pc:chgData name="Wilson, Iain (A&amp;F, Black Mountain)" userId="38bfd345-1638-4364-807f-ad09d9a3cd4c" providerId="ADAL" clId="{C75939C2-CE78-4B04-B436-754E9745B2B3}" dt="2023-11-29T02:40:48.827" v="14" actId="20577"/>
        <pc:sldMkLst>
          <pc:docMk/>
          <pc:sldMk cId="3506753633" sldId="349"/>
        </pc:sldMkLst>
        <pc:spChg chg="mod">
          <ac:chgData name="Wilson, Iain (A&amp;F, Black Mountain)" userId="38bfd345-1638-4364-807f-ad09d9a3cd4c" providerId="ADAL" clId="{C75939C2-CE78-4B04-B436-754E9745B2B3}" dt="2023-11-29T02:40:48.827" v="14" actId="20577"/>
          <ac:spMkLst>
            <pc:docMk/>
            <pc:sldMk cId="3506753633" sldId="349"/>
            <ac:spMk id="5" creationId="{2F7D72F6-909E-26F4-3932-4CBD2C650FED}"/>
          </ac:spMkLst>
        </pc:spChg>
      </pc:sldChg>
      <pc:sldChg chg="modSp add mod">
        <pc:chgData name="Wilson, Iain (A&amp;F, Black Mountain)" userId="38bfd345-1638-4364-807f-ad09d9a3cd4c" providerId="ADAL" clId="{C75939C2-CE78-4B04-B436-754E9745B2B3}" dt="2023-11-29T02:40:40.324" v="12" actId="20577"/>
        <pc:sldMkLst>
          <pc:docMk/>
          <pc:sldMk cId="1554069352" sldId="350"/>
        </pc:sldMkLst>
        <pc:spChg chg="mod">
          <ac:chgData name="Wilson, Iain (A&amp;F, Black Mountain)" userId="38bfd345-1638-4364-807f-ad09d9a3cd4c" providerId="ADAL" clId="{C75939C2-CE78-4B04-B436-754E9745B2B3}" dt="2023-11-29T02:40:40.324" v="12" actId="20577"/>
          <ac:spMkLst>
            <pc:docMk/>
            <pc:sldMk cId="1554069352" sldId="350"/>
            <ac:spMk id="7" creationId="{1A995D90-847A-6377-6ED4-2ABFEE24DE16}"/>
          </ac:spMkLst>
        </pc:spChg>
      </pc:sldChg>
    </pc:docChg>
  </pc:docChgLst>
  <pc:docChgLst>
    <pc:chgData name="Wilson, Iain (A&amp;F, Black Mountain)" userId="38bfd345-1638-4364-807f-ad09d9a3cd4c" providerId="ADAL" clId="{F2618B73-FAF6-48E6-B9AE-E16558DAED58}"/>
    <pc:docChg chg="modSld">
      <pc:chgData name="Wilson, Iain (A&amp;F, Black Mountain)" userId="38bfd345-1638-4364-807f-ad09d9a3cd4c" providerId="ADAL" clId="{F2618B73-FAF6-48E6-B9AE-E16558DAED58}" dt="2024-02-19T02:35:29.618" v="5" actId="20577"/>
      <pc:docMkLst>
        <pc:docMk/>
      </pc:docMkLst>
      <pc:sldChg chg="modSp mod">
        <pc:chgData name="Wilson, Iain (A&amp;F, Black Mountain)" userId="38bfd345-1638-4364-807f-ad09d9a3cd4c" providerId="ADAL" clId="{F2618B73-FAF6-48E6-B9AE-E16558DAED58}" dt="2024-02-19T02:35:29.618" v="5" actId="20577"/>
        <pc:sldMkLst>
          <pc:docMk/>
          <pc:sldMk cId="998421246" sldId="258"/>
        </pc:sldMkLst>
        <pc:spChg chg="mod">
          <ac:chgData name="Wilson, Iain (A&amp;F, Black Mountain)" userId="38bfd345-1638-4364-807f-ad09d9a3cd4c" providerId="ADAL" clId="{F2618B73-FAF6-48E6-B9AE-E16558DAED58}" dt="2024-02-19T02:35:29.618" v="5" actId="20577"/>
          <ac:spMkLst>
            <pc:docMk/>
            <pc:sldMk cId="998421246" sldId="258"/>
            <ac:spMk id="9" creationId="{6448A63B-6CA8-327A-C701-C92FADC8BD8C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csiroau-my.sharepoint.com/personal/wil194_csiro_au/Documents/Documents/Cotton/Verticillium/MCU%20paper%20work/Zitong/Phenotype%20data%20given%20to%20Zitong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csiroau-my.sharepoint.com/personal/wil194_csiro_au/Documents/Documents/Cotton/Verticillium/MCU%20paper%20work/Zitong/Phenotype%20data%20given%20to%20Zitong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'By %'!$P$37:$P$46</c:f>
              <c:strCache>
                <c:ptCount val="10"/>
                <c:pt idx="0">
                  <c:v>0-10</c:v>
                </c:pt>
                <c:pt idx="1">
                  <c:v>10-20</c:v>
                </c:pt>
                <c:pt idx="2">
                  <c:v>20-30</c:v>
                </c:pt>
                <c:pt idx="3">
                  <c:v>30-40</c:v>
                </c:pt>
                <c:pt idx="4">
                  <c:v>40-50</c:v>
                </c:pt>
                <c:pt idx="5">
                  <c:v>50-60</c:v>
                </c:pt>
                <c:pt idx="6">
                  <c:v>60-70</c:v>
                </c:pt>
                <c:pt idx="7">
                  <c:v>70-80</c:v>
                </c:pt>
                <c:pt idx="8">
                  <c:v>80-90</c:v>
                </c:pt>
                <c:pt idx="9">
                  <c:v>90-100</c:v>
                </c:pt>
              </c:strCache>
            </c:strRef>
          </c:cat>
          <c:val>
            <c:numRef>
              <c:f>'By %'!$Q$37:$Q$46</c:f>
              <c:numCache>
                <c:formatCode>General</c:formatCode>
                <c:ptCount val="10"/>
                <c:pt idx="0">
                  <c:v>75</c:v>
                </c:pt>
                <c:pt idx="1">
                  <c:v>48</c:v>
                </c:pt>
                <c:pt idx="2">
                  <c:v>24</c:v>
                </c:pt>
                <c:pt idx="3">
                  <c:v>19</c:v>
                </c:pt>
                <c:pt idx="4">
                  <c:v>9</c:v>
                </c:pt>
                <c:pt idx="5">
                  <c:v>12</c:v>
                </c:pt>
                <c:pt idx="6">
                  <c:v>8</c:v>
                </c:pt>
                <c:pt idx="7">
                  <c:v>8</c:v>
                </c:pt>
                <c:pt idx="8">
                  <c:v>14</c:v>
                </c:pt>
                <c:pt idx="9">
                  <c:v>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4FC-456A-9C53-CC3FB8CAABC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3"/>
        <c:overlap val="-27"/>
        <c:axId val="2121187872"/>
        <c:axId val="2137440736"/>
      </c:barChart>
      <c:catAx>
        <c:axId val="21211878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37440736"/>
        <c:crosses val="autoZero"/>
        <c:auto val="1"/>
        <c:lblAlgn val="ctr"/>
        <c:lblOffset val="100"/>
        <c:noMultiLvlLbl val="0"/>
      </c:catAx>
      <c:valAx>
        <c:axId val="213744073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211878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'By %'!$T$37:$T$46</c:f>
              <c:strCache>
                <c:ptCount val="10"/>
                <c:pt idx="0">
                  <c:v>0-10</c:v>
                </c:pt>
                <c:pt idx="1">
                  <c:v>10-20</c:v>
                </c:pt>
                <c:pt idx="2">
                  <c:v>20-30</c:v>
                </c:pt>
                <c:pt idx="3">
                  <c:v>30-40</c:v>
                </c:pt>
                <c:pt idx="4">
                  <c:v>40-50</c:v>
                </c:pt>
                <c:pt idx="5">
                  <c:v>50-60</c:v>
                </c:pt>
                <c:pt idx="6">
                  <c:v>60-70</c:v>
                </c:pt>
                <c:pt idx="7">
                  <c:v>70-80</c:v>
                </c:pt>
                <c:pt idx="8">
                  <c:v>80-90</c:v>
                </c:pt>
                <c:pt idx="9">
                  <c:v>90-100</c:v>
                </c:pt>
              </c:strCache>
            </c:strRef>
          </c:cat>
          <c:val>
            <c:numRef>
              <c:f>'By %'!$U$37:$U$46</c:f>
              <c:numCache>
                <c:formatCode>General</c:formatCode>
                <c:ptCount val="10"/>
                <c:pt idx="0">
                  <c:v>4</c:v>
                </c:pt>
                <c:pt idx="1">
                  <c:v>75</c:v>
                </c:pt>
                <c:pt idx="2">
                  <c:v>73</c:v>
                </c:pt>
                <c:pt idx="3">
                  <c:v>41</c:v>
                </c:pt>
                <c:pt idx="4">
                  <c:v>22</c:v>
                </c:pt>
                <c:pt idx="5">
                  <c:v>12</c:v>
                </c:pt>
                <c:pt idx="6">
                  <c:v>11</c:v>
                </c:pt>
                <c:pt idx="7">
                  <c:v>0</c:v>
                </c:pt>
                <c:pt idx="8">
                  <c:v>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752-4B75-9E9B-38D51E1DE21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3"/>
        <c:overlap val="-27"/>
        <c:axId val="447400384"/>
        <c:axId val="2076117648"/>
      </c:barChart>
      <c:catAx>
        <c:axId val="4474003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76117648"/>
        <c:crosses val="autoZero"/>
        <c:auto val="1"/>
        <c:lblAlgn val="ctr"/>
        <c:lblOffset val="100"/>
        <c:noMultiLvlLbl val="0"/>
      </c:catAx>
      <c:valAx>
        <c:axId val="207611764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474003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78E470-24D0-5B28-CAC0-51441C45AE6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C201EA5-144F-D31B-3CC7-A73E40268BF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C6067C-DDC0-490B-7BD1-50EC9CF3AB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B6A02F-07B1-4BDC-918A-C1A4003DE033}" type="datetimeFigureOut">
              <a:rPr lang="en-AU" smtClean="0"/>
              <a:t>19/02/2024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F37572-4F9D-E4DA-C505-3528869FA2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DA0E2F-6B78-5013-E5F2-3474E5C772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85259D-8AF1-4117-A71D-AC3041F4098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197654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5385C6-50C8-8E5B-2B19-AB48F675FB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A53279B-505B-678B-F6E6-40165409908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34257B-4D33-B7CD-A160-85B405CDE2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B6A02F-07B1-4BDC-918A-C1A4003DE033}" type="datetimeFigureOut">
              <a:rPr lang="en-AU" smtClean="0"/>
              <a:t>19/02/2024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0875EE-E82D-3DF5-6BE5-2EE48E1760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83D339-30D6-444C-E7B1-C7EDE27D7B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85259D-8AF1-4117-A71D-AC3041F4098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710124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9EE7E01-65FA-C465-71A1-BFA7AB19038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5876612-75B2-3DE1-F714-F49D90FAB0F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35BD1B-3956-CB77-2DD3-E4CD42E52A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B6A02F-07B1-4BDC-918A-C1A4003DE033}" type="datetimeFigureOut">
              <a:rPr lang="en-AU" smtClean="0"/>
              <a:t>19/02/2024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BFB58B-8B05-7522-E27A-E821051496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6B562C-A4DD-D0C1-870D-A0644D948F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85259D-8AF1-4117-A71D-AC3041F4098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43431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80FF3B-BA55-85D5-1AA1-1E0F94AB66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7D5EB5C-9CD0-CB45-77E3-49FF256EAE6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933D4B-BAFE-61D0-1360-85D59B3D38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B6A02F-07B1-4BDC-918A-C1A4003DE033}" type="datetimeFigureOut">
              <a:rPr lang="en-AU" smtClean="0"/>
              <a:t>19/02/2024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49A3FA-4950-2656-958E-8185EC6483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F12E79-E909-747A-E6E2-358441FA5B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85259D-8AF1-4117-A71D-AC3041F4098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914984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172470-B424-E490-A572-74F9832211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1D7E0A8-E0CD-869B-7344-B29D447438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796E25-05F2-34D3-0B6F-423B397DD0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B6A02F-07B1-4BDC-918A-C1A4003DE033}" type="datetimeFigureOut">
              <a:rPr lang="en-AU" smtClean="0"/>
              <a:t>19/02/2024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8E5DDA-23F1-C3EE-6D26-75C6BA5C7D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0E304E-D3E4-C473-A954-563CA692E5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85259D-8AF1-4117-A71D-AC3041F4098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014745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E7D1D7-4058-05B1-310F-92BCA4EC79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4EF6B67-096D-DAF7-96A5-3C4CBF5B030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1244A07-386E-7238-8F83-1106D51A7EB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153820F-2758-4A2A-9676-02D0E4B451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B6A02F-07B1-4BDC-918A-C1A4003DE033}" type="datetimeFigureOut">
              <a:rPr lang="en-AU" smtClean="0"/>
              <a:t>19/02/2024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6C21E7F-59AD-7BD0-D51F-74D77E4638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EA21661-7C88-FC08-0306-13998A94FF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85259D-8AF1-4117-A71D-AC3041F4098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16543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87513A-9E87-AA56-E9DC-033E64D378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87E3C80-6E25-E31F-F9CE-CF7D7D4BDA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2A1DB15-258B-3DB4-90D5-C29FDB6985F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5D37C7D-3621-76A4-FA4C-B423532B9DF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4BB1352-2106-13F1-60BB-4A384360311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5A88E59-0499-90BF-7BAE-5B7C8D70E9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B6A02F-07B1-4BDC-918A-C1A4003DE033}" type="datetimeFigureOut">
              <a:rPr lang="en-AU" smtClean="0"/>
              <a:t>19/02/2024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C2E8405-F140-E60C-C160-2428F6E11E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06E0567-126E-B1C3-8257-358EBC9169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85259D-8AF1-4117-A71D-AC3041F4098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751840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3BE5F1-39BD-E7B0-3CE9-8DD14CFC78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2289F06-681A-C010-041D-382226A4CA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B6A02F-07B1-4BDC-918A-C1A4003DE033}" type="datetimeFigureOut">
              <a:rPr lang="en-AU" smtClean="0"/>
              <a:t>19/02/2024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CD6F813-6C7D-3F0C-5A23-145EF58D1D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6966B8A-D040-9AD8-2015-5319599A5B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85259D-8AF1-4117-A71D-AC3041F4098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289008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B269856-7D02-D498-3FAE-2F0ECA18D3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B6A02F-07B1-4BDC-918A-C1A4003DE033}" type="datetimeFigureOut">
              <a:rPr lang="en-AU" smtClean="0"/>
              <a:t>19/02/2024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AD366A3-9D6B-DB5E-E336-EB6AE1151F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8B823B7-7108-C759-6BC7-43A6D975C8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85259D-8AF1-4117-A71D-AC3041F4098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919158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A5D4D6-CD5D-9826-DF15-A4FD59651E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00F07E5-4B6F-514E-2F81-76277E9DDF0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FC554A4-973D-BCBB-A6D2-1E7D2B4BE6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B8CB656-6A87-A2ED-E8E8-7DC6FD4A59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B6A02F-07B1-4BDC-918A-C1A4003DE033}" type="datetimeFigureOut">
              <a:rPr lang="en-AU" smtClean="0"/>
              <a:t>19/02/2024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55B9F43-F379-9E0F-DC22-DF807647BA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95CC9EB-971C-39CF-DF7B-4C5A00046B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85259D-8AF1-4117-A71D-AC3041F4098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653612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2AA0D5-0284-2C76-BC8F-7EA4C3BDC3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46C2E67-509C-17A3-6DD6-2E09B934662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FC38DF5-92DF-C05D-215C-954BB30C963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4D39701-9402-317E-CA83-A0AEFD32B9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B6A02F-07B1-4BDC-918A-C1A4003DE033}" type="datetimeFigureOut">
              <a:rPr lang="en-AU" smtClean="0"/>
              <a:t>19/02/2024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9F9FDC1-9B10-60DA-ADE6-8F1414C479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9AC75A2-9174-050B-D91D-A8E64AF3A6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85259D-8AF1-4117-A71D-AC3041F4098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329512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8156066-37BD-EB2D-7630-32A2995C43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E6511C4-22E2-E75E-3E6D-7A9A6F45B7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24B1D8-91D3-6F6F-5FBD-B21E9D29034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B6A02F-07B1-4BDC-918A-C1A4003DE033}" type="datetimeFigureOut">
              <a:rPr lang="en-AU" smtClean="0"/>
              <a:t>19/02/2024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A1372A-1E18-DE61-AAC2-56669EC4527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B121DE-09EB-4E54-BC86-DF926D6F643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85259D-8AF1-4117-A71D-AC3041F4098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243602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7C1F50C0-3C73-C46C-A6D2-0048E46B9301}"/>
              </a:ext>
            </a:extLst>
          </p:cNvPr>
          <p:cNvGraphicFramePr>
            <a:graphicFrameLocks/>
          </p:cNvGraphicFramePr>
          <p:nvPr/>
        </p:nvGraphicFramePr>
        <p:xfrm>
          <a:off x="2060604" y="1031050"/>
          <a:ext cx="7843972" cy="47063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1DB150FB-3BBF-8736-AF4F-80BEB618B058}"/>
              </a:ext>
            </a:extLst>
          </p:cNvPr>
          <p:cNvSpPr txBox="1"/>
          <p:nvPr/>
        </p:nvSpPr>
        <p:spPr>
          <a:xfrm>
            <a:off x="2189629" y="6191515"/>
            <a:ext cx="854635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400" dirty="0"/>
              <a:t>Figure S1. Distribution of relative survival % in the MCU-5 x Siokra 1-4 RIL F</a:t>
            </a:r>
            <a:r>
              <a:rPr lang="en-US" sz="1400" baseline="-25000" dirty="0"/>
              <a:t>7</a:t>
            </a:r>
            <a:r>
              <a:rPr lang="en-US" sz="1400" dirty="0"/>
              <a:t> population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8C8180A-5B94-E09D-82B3-C8A2C5497471}"/>
              </a:ext>
            </a:extLst>
          </p:cNvPr>
          <p:cNvSpPr txBox="1"/>
          <p:nvPr/>
        </p:nvSpPr>
        <p:spPr>
          <a:xfrm rot="16200000">
            <a:off x="804651" y="3214964"/>
            <a:ext cx="16754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Number of F</a:t>
            </a:r>
            <a:r>
              <a:rPr lang="en-US" sz="1600" baseline="-25000" dirty="0"/>
              <a:t>7</a:t>
            </a:r>
            <a:r>
              <a:rPr lang="en-US" sz="1600" dirty="0"/>
              <a:t> RILs</a:t>
            </a:r>
            <a:endParaRPr lang="en-AU" sz="16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D4A51AE-7C16-F4F1-B6D2-4E685CF1433F}"/>
              </a:ext>
            </a:extLst>
          </p:cNvPr>
          <p:cNvSpPr txBox="1"/>
          <p:nvPr/>
        </p:nvSpPr>
        <p:spPr>
          <a:xfrm>
            <a:off x="5383192" y="5737434"/>
            <a:ext cx="15747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Line survival %</a:t>
            </a: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41915201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A9037A25-5B12-76C5-A350-A63C25E1CAE8}"/>
              </a:ext>
            </a:extLst>
          </p:cNvPr>
          <p:cNvGraphicFramePr>
            <a:graphicFrameLocks/>
          </p:cNvGraphicFramePr>
          <p:nvPr/>
        </p:nvGraphicFramePr>
        <p:xfrm>
          <a:off x="2069487" y="1034536"/>
          <a:ext cx="7909719" cy="47063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33F5CBDE-0224-9FA8-C39E-2650452D46D2}"/>
              </a:ext>
            </a:extLst>
          </p:cNvPr>
          <p:cNvSpPr txBox="1"/>
          <p:nvPr/>
        </p:nvSpPr>
        <p:spPr>
          <a:xfrm rot="16200000">
            <a:off x="804651" y="3214964"/>
            <a:ext cx="16754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Number of F</a:t>
            </a:r>
            <a:r>
              <a:rPr lang="en-US" sz="1600" baseline="-25000" dirty="0"/>
              <a:t>7</a:t>
            </a:r>
            <a:r>
              <a:rPr lang="en-US" sz="1600" dirty="0"/>
              <a:t> RILs</a:t>
            </a:r>
            <a:endParaRPr lang="en-AU" sz="16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70998D5-F54C-2B9A-9EEF-0C45C642FE68}"/>
              </a:ext>
            </a:extLst>
          </p:cNvPr>
          <p:cNvSpPr txBox="1"/>
          <p:nvPr/>
        </p:nvSpPr>
        <p:spPr>
          <a:xfrm>
            <a:off x="2424952" y="6177245"/>
            <a:ext cx="854635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400" dirty="0"/>
              <a:t>Figure S2. Distribution of relative weight % in the MCU-5 x Siokra 1-4 RIL F</a:t>
            </a:r>
            <a:r>
              <a:rPr lang="en-US" sz="1400" baseline="-25000" dirty="0"/>
              <a:t>7</a:t>
            </a:r>
            <a:r>
              <a:rPr lang="en-US" sz="1400" dirty="0"/>
              <a:t> populatio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448A63B-6CA8-327A-C701-C92FADC8BD8C}"/>
              </a:ext>
            </a:extLst>
          </p:cNvPr>
          <p:cNvSpPr txBox="1"/>
          <p:nvPr/>
        </p:nvSpPr>
        <p:spPr>
          <a:xfrm>
            <a:off x="5221821" y="5737434"/>
            <a:ext cx="2065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Line shoot weight %</a:t>
            </a: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9984212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70585B2-89A8-5FD7-FE4B-8384E1C9B97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85249"/>
            <a:ext cx="12192000" cy="4571522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37C78FD8-EBB4-B56F-3671-AA91B3EAF40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70721" y="4124836"/>
            <a:ext cx="2257138" cy="1524001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6C73BFD1-B14F-5826-EA39-D18B75FA1528}"/>
              </a:ext>
            </a:extLst>
          </p:cNvPr>
          <p:cNvSpPr/>
          <p:nvPr/>
        </p:nvSpPr>
        <p:spPr>
          <a:xfrm>
            <a:off x="1911015" y="6057236"/>
            <a:ext cx="7738311" cy="3440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AU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3  GO terms associated with MCU-5</a:t>
            </a:r>
            <a:r>
              <a:rPr lang="en-AU" sz="16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AU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ranscriptional responses to infection at 6 </a:t>
            </a:r>
            <a:r>
              <a:rPr lang="en-AU" sz="16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pi</a:t>
            </a:r>
            <a:endParaRPr lang="en-AU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396138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A5EB8A9-274A-155A-E66D-25C2525D929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158" y="525493"/>
            <a:ext cx="12192000" cy="4736202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9627A23F-AB7D-94CE-DBE6-05343DDFE53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70721" y="4124836"/>
            <a:ext cx="2257138" cy="1524001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CD042B15-0ECF-F82D-6E72-D95EA4968056}"/>
              </a:ext>
            </a:extLst>
          </p:cNvPr>
          <p:cNvSpPr/>
          <p:nvPr/>
        </p:nvSpPr>
        <p:spPr>
          <a:xfrm>
            <a:off x="1911015" y="6057236"/>
            <a:ext cx="7738311" cy="3440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AU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4  GO terms associated with MCU-5</a:t>
            </a:r>
            <a:r>
              <a:rPr lang="en-AU" sz="16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AU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ranscriptional responses to infection at 1 dpi</a:t>
            </a:r>
          </a:p>
        </p:txBody>
      </p:sp>
    </p:spTree>
    <p:extLst>
      <p:ext uri="{BB962C8B-B14F-4D97-AF65-F5344CB8AC3E}">
        <p14:creationId xmlns:p14="http://schemas.microsoft.com/office/powerpoint/2010/main" val="210451885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21924BB-B643-3967-4E8E-3C4BC941081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69559" y="0"/>
            <a:ext cx="9258300" cy="5286375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0F2A5837-87CB-6C25-2864-30A69473ED2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67074" y="4341405"/>
            <a:ext cx="2257138" cy="1524001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C78A81F4-1564-1DFC-8B11-6AFAF2F29106}"/>
              </a:ext>
            </a:extLst>
          </p:cNvPr>
          <p:cNvSpPr/>
          <p:nvPr/>
        </p:nvSpPr>
        <p:spPr>
          <a:xfrm>
            <a:off x="1911015" y="6057236"/>
            <a:ext cx="7738311" cy="3440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AU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5  GO terms associated with MCU-5</a:t>
            </a:r>
            <a:r>
              <a:rPr lang="en-AU" sz="16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AU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ranscriptional responses to infection at 3 dpi</a:t>
            </a:r>
          </a:p>
        </p:txBody>
      </p:sp>
    </p:spTree>
    <p:extLst>
      <p:ext uri="{BB962C8B-B14F-4D97-AF65-F5344CB8AC3E}">
        <p14:creationId xmlns:p14="http://schemas.microsoft.com/office/powerpoint/2010/main" val="209331472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5D5518E3-2C7C-EE78-7749-0FC9F7A56C3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127" y="717299"/>
            <a:ext cx="12192000" cy="3594602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221DAE59-8158-8E5E-0EC3-7654606ED9A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67074" y="4341405"/>
            <a:ext cx="2257138" cy="1524001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1A995D90-847A-6377-6ED4-2ABFEE24DE16}"/>
              </a:ext>
            </a:extLst>
          </p:cNvPr>
          <p:cNvSpPr/>
          <p:nvPr/>
        </p:nvSpPr>
        <p:spPr>
          <a:xfrm>
            <a:off x="1911015" y="6057236"/>
            <a:ext cx="8057148" cy="3440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AU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6  GO terms associated with Siokra 1-4</a:t>
            </a:r>
            <a:r>
              <a:rPr lang="en-AU" sz="16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AU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ranscriptional responses to infection at 6 </a:t>
            </a:r>
            <a:r>
              <a:rPr lang="en-AU" sz="16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pi</a:t>
            </a:r>
            <a:endParaRPr lang="en-AU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5406935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35B50102-4733-0C1E-EBD3-C28C4923E09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67853" y="392780"/>
            <a:ext cx="7794207" cy="4665595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91058C35-7C7A-B1DA-5FC2-5AE89419B4C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48337" y="4473752"/>
            <a:ext cx="2257138" cy="1524001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BBEAF3A4-BB60-0CD3-5F77-FACFB1A297D4}"/>
              </a:ext>
            </a:extLst>
          </p:cNvPr>
          <p:cNvSpPr/>
          <p:nvPr/>
        </p:nvSpPr>
        <p:spPr>
          <a:xfrm>
            <a:off x="1911015" y="6057236"/>
            <a:ext cx="8057148" cy="3440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AU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7  GO terms associated with Siokra 1-4</a:t>
            </a:r>
            <a:r>
              <a:rPr lang="en-AU" sz="16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AU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ranscriptional responses to infection at 1 dpi</a:t>
            </a:r>
          </a:p>
        </p:txBody>
      </p:sp>
    </p:spTree>
    <p:extLst>
      <p:ext uri="{BB962C8B-B14F-4D97-AF65-F5344CB8AC3E}">
        <p14:creationId xmlns:p14="http://schemas.microsoft.com/office/powerpoint/2010/main" val="111934730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DC92D67-488D-EFEB-C60F-28849A3FFF2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244163"/>
            <a:ext cx="12192000" cy="1915231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6B776052-07BD-7D64-CE07-EAECCA1A863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05437" y="4089836"/>
            <a:ext cx="2257138" cy="1524001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2F7D72F6-909E-26F4-3932-4CBD2C650FED}"/>
              </a:ext>
            </a:extLst>
          </p:cNvPr>
          <p:cNvSpPr/>
          <p:nvPr/>
        </p:nvSpPr>
        <p:spPr>
          <a:xfrm>
            <a:off x="1911015" y="6057236"/>
            <a:ext cx="8057148" cy="3440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AU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8  GO terms associated with Siokra 1-4</a:t>
            </a:r>
            <a:r>
              <a:rPr lang="en-AU" sz="16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AU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ranscriptional responses to infection at 3 dpi</a:t>
            </a:r>
          </a:p>
        </p:txBody>
      </p:sp>
    </p:spTree>
    <p:extLst>
      <p:ext uri="{BB962C8B-B14F-4D97-AF65-F5344CB8AC3E}">
        <p14:creationId xmlns:p14="http://schemas.microsoft.com/office/powerpoint/2010/main" val="35067536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212</TotalTime>
  <Words>136</Words>
  <Application>Microsoft Office PowerPoint</Application>
  <PresentationFormat>Widescreen</PresentationFormat>
  <Paragraphs>12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CSIR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lson, Iain (A&amp;F, Black Mountain)</dc:creator>
  <cp:lastModifiedBy>Wilson, Iain (A&amp;F, Black Mountain)</cp:lastModifiedBy>
  <cp:revision>1</cp:revision>
  <dcterms:created xsi:type="dcterms:W3CDTF">2023-11-24T02:28:06Z</dcterms:created>
  <dcterms:modified xsi:type="dcterms:W3CDTF">2024-02-19T02:35:37Z</dcterms:modified>
</cp:coreProperties>
</file>